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4" r:id="rId2"/>
    <p:sldId id="273" r:id="rId3"/>
    <p:sldId id="275" r:id="rId4"/>
    <p:sldId id="272" r:id="rId5"/>
    <p:sldId id="268" r:id="rId6"/>
    <p:sldId id="265" r:id="rId7"/>
    <p:sldId id="269" r:id="rId8"/>
    <p:sldId id="276" r:id="rId9"/>
    <p:sldId id="270" r:id="rId10"/>
    <p:sldId id="271" r:id="rId11"/>
  </p:sldIdLst>
  <p:sldSz cx="9906000" cy="6858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1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41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3" y="3602040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200" indent="0" algn="ctr">
              <a:buNone/>
              <a:defRPr sz="2001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599"/>
            </a:lvl4pPr>
            <a:lvl5pPr marL="1828801" indent="0" algn="ctr">
              <a:buNone/>
              <a:defRPr sz="1599"/>
            </a:lvl5pPr>
            <a:lvl6pPr marL="2286001" indent="0" algn="ctr">
              <a:buNone/>
              <a:defRPr sz="1599"/>
            </a:lvl6pPr>
            <a:lvl7pPr marL="2743203" indent="0" algn="ctr">
              <a:buNone/>
              <a:defRPr sz="1599"/>
            </a:lvl7pPr>
            <a:lvl8pPr marL="3200403" indent="0" algn="ctr">
              <a:buNone/>
              <a:defRPr sz="1599"/>
            </a:lvl8pPr>
            <a:lvl9pPr marL="3657603" indent="0" algn="ctr">
              <a:buNone/>
              <a:defRPr sz="1599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4056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4146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9" y="365125"/>
            <a:ext cx="628412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7449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0930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0" y="1709742"/>
            <a:ext cx="8543924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0" y="4589467"/>
            <a:ext cx="8543924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200" indent="0">
              <a:buNone/>
              <a:defRPr sz="2001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4pPr>
            <a:lvl5pPr marL="1828801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5pPr>
            <a:lvl6pPr marL="2286001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6pPr>
            <a:lvl7pPr marL="2743203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7pPr>
            <a:lvl8pPr marL="3200403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8pPr>
            <a:lvl9pPr marL="3657603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1019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6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5996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9"/>
            <a:ext cx="8543924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00" indent="0">
              <a:buNone/>
              <a:defRPr sz="2001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599" b="1"/>
            </a:lvl4pPr>
            <a:lvl5pPr marL="1828801" indent="0">
              <a:buNone/>
              <a:defRPr sz="1599" b="1"/>
            </a:lvl5pPr>
            <a:lvl6pPr marL="2286001" indent="0">
              <a:buNone/>
              <a:defRPr sz="1599" b="1"/>
            </a:lvl6pPr>
            <a:lvl7pPr marL="2743203" indent="0">
              <a:buNone/>
              <a:defRPr sz="1599" b="1"/>
            </a:lvl7pPr>
            <a:lvl8pPr marL="3200403" indent="0">
              <a:buNone/>
              <a:defRPr sz="1599" b="1"/>
            </a:lvl8pPr>
            <a:lvl9pPr marL="3657603" indent="0">
              <a:buNone/>
              <a:defRPr sz="1599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5" y="1681163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00" indent="0">
              <a:buNone/>
              <a:defRPr sz="2001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599" b="1"/>
            </a:lvl4pPr>
            <a:lvl5pPr marL="1828801" indent="0">
              <a:buNone/>
              <a:defRPr sz="1599" b="1"/>
            </a:lvl5pPr>
            <a:lvl6pPr marL="2286001" indent="0">
              <a:buNone/>
              <a:defRPr sz="1599" b="1"/>
            </a:lvl6pPr>
            <a:lvl7pPr marL="2743203" indent="0">
              <a:buNone/>
              <a:defRPr sz="1599" b="1"/>
            </a:lvl7pPr>
            <a:lvl8pPr marL="3200403" indent="0">
              <a:buNone/>
              <a:defRPr sz="1599" b="1"/>
            </a:lvl8pPr>
            <a:lvl9pPr marL="3657603" indent="0">
              <a:buNone/>
              <a:defRPr sz="1599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5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2338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9208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7349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3" y="987429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1"/>
            </a:lvl3pPr>
            <a:lvl4pPr>
              <a:defRPr sz="2001"/>
            </a:lvl4pPr>
            <a:lvl5pPr>
              <a:defRPr sz="2001"/>
            </a:lvl5pPr>
            <a:lvl6pPr>
              <a:defRPr sz="2001"/>
            </a:lvl6pPr>
            <a:lvl7pPr>
              <a:defRPr sz="2001"/>
            </a:lvl7pPr>
            <a:lvl8pPr>
              <a:defRPr sz="2001"/>
            </a:lvl8pPr>
            <a:lvl9pPr>
              <a:defRPr sz="200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2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200" indent="0">
              <a:buNone/>
              <a:defRPr sz="1400"/>
            </a:lvl2pPr>
            <a:lvl3pPr marL="914400" indent="0">
              <a:buNone/>
              <a:defRPr sz="1199"/>
            </a:lvl3pPr>
            <a:lvl4pPr marL="1371600" indent="0">
              <a:buNone/>
              <a:defRPr sz="1000"/>
            </a:lvl4pPr>
            <a:lvl5pPr marL="1828801" indent="0">
              <a:buNone/>
              <a:defRPr sz="1000"/>
            </a:lvl5pPr>
            <a:lvl6pPr marL="2286001" indent="0">
              <a:buNone/>
              <a:defRPr sz="1000"/>
            </a:lvl6pPr>
            <a:lvl7pPr marL="2743203" indent="0">
              <a:buNone/>
              <a:defRPr sz="1000"/>
            </a:lvl7pPr>
            <a:lvl8pPr marL="3200403" indent="0">
              <a:buNone/>
              <a:defRPr sz="1000"/>
            </a:lvl8pPr>
            <a:lvl9pPr marL="3657603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8844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3" y="987429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1"/>
            </a:lvl3pPr>
            <a:lvl4pPr marL="1371600" indent="0">
              <a:buNone/>
              <a:defRPr sz="2001"/>
            </a:lvl4pPr>
            <a:lvl5pPr marL="1828801" indent="0">
              <a:buNone/>
              <a:defRPr sz="2001"/>
            </a:lvl5pPr>
            <a:lvl6pPr marL="2286001" indent="0">
              <a:buNone/>
              <a:defRPr sz="2001"/>
            </a:lvl6pPr>
            <a:lvl7pPr marL="2743203" indent="0">
              <a:buNone/>
              <a:defRPr sz="2001"/>
            </a:lvl7pPr>
            <a:lvl8pPr marL="3200403" indent="0">
              <a:buNone/>
              <a:defRPr sz="2001"/>
            </a:lvl8pPr>
            <a:lvl9pPr marL="3657603" indent="0">
              <a:buNone/>
              <a:defRPr sz="2001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2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200" indent="0">
              <a:buNone/>
              <a:defRPr sz="1400"/>
            </a:lvl2pPr>
            <a:lvl3pPr marL="914400" indent="0">
              <a:buNone/>
              <a:defRPr sz="1199"/>
            </a:lvl3pPr>
            <a:lvl4pPr marL="1371600" indent="0">
              <a:buNone/>
              <a:defRPr sz="1000"/>
            </a:lvl4pPr>
            <a:lvl5pPr marL="1828801" indent="0">
              <a:buNone/>
              <a:defRPr sz="1000"/>
            </a:lvl5pPr>
            <a:lvl6pPr marL="2286001" indent="0">
              <a:buNone/>
              <a:defRPr sz="1000"/>
            </a:lvl6pPr>
            <a:lvl7pPr marL="2743203" indent="0">
              <a:buNone/>
              <a:defRPr sz="1000"/>
            </a:lvl7pPr>
            <a:lvl8pPr marL="3200403" indent="0">
              <a:buNone/>
              <a:defRPr sz="1000"/>
            </a:lvl8pPr>
            <a:lvl9pPr marL="3657603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0062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9"/>
            <a:ext cx="854392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4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9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04546-D1F8-4902-B079-FFBAB78EBB8B}" type="datetimeFigureOut">
              <a:rPr lang="it-IT" smtClean="0"/>
              <a:t>25/09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7" y="6356354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D44D8-0B18-4416-85CB-C1D6AD29554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7733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3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001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3" indent="-228600" algn="l" defTabSz="914400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1" indent="-228600" algn="l" defTabSz="914400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1" indent="-228600" algn="l" defTabSz="914400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3" indent="-228600" algn="l" defTabSz="914400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3" indent="-228600" algn="l" defTabSz="914400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3" indent="-228600" algn="l" defTabSz="914400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1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1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3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3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3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xmlns="" id="{84758303-73E5-4E49-9425-64E614511101}"/>
              </a:ext>
            </a:extLst>
          </p:cNvPr>
          <p:cNvSpPr txBox="1"/>
          <p:nvPr/>
        </p:nvSpPr>
        <p:spPr>
          <a:xfrm>
            <a:off x="7767833" y="6573947"/>
            <a:ext cx="179632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</a:t>
            </a:r>
            <a:r>
              <a:rPr lang="it-IT" sz="1245" dirty="0" smtClean="0"/>
              <a:t>1</a:t>
            </a:r>
            <a:endParaRPr lang="it-IT" sz="1245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14B6F5D1-47D7-4DCF-8807-7C71A619787C}"/>
              </a:ext>
            </a:extLst>
          </p:cNvPr>
          <p:cNvSpPr txBox="1"/>
          <p:nvPr/>
        </p:nvSpPr>
        <p:spPr>
          <a:xfrm>
            <a:off x="416759" y="6112282"/>
            <a:ext cx="89696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Who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ectropherogram related to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HR exon 10 sequence data </a:t>
            </a:r>
            <a:r>
              <a:rPr lang="en-US" sz="1200" dirty="0" smtClean="0"/>
              <a:t>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hr7:17339632+17340337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c.1239-c.2056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umor DNA #1 depicted in Figure 1C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lef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Ima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elect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rti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n in the original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lighted in red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5579" y="839002"/>
            <a:ext cx="7071973" cy="49259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18473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C31326DD-FE82-43C6-B7BB-50026D97BD96}"/>
              </a:ext>
            </a:extLst>
          </p:cNvPr>
          <p:cNvSpPr txBox="1"/>
          <p:nvPr/>
        </p:nvSpPr>
        <p:spPr>
          <a:xfrm>
            <a:off x="198304" y="5937742"/>
            <a:ext cx="95846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0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Who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ectropherogram related to AHR exon 10 sequence data (chr7:17339322+17339650; c. 1497-c. 1825) of tumor DNA #1 depicted in Figure 3B (left panel)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quenc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alysis was performed with reverse primer.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ma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elected portion shown in the original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lighted in red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xmlns="" id="{0B8044FD-D9BC-4594-8412-87378BF42634}"/>
              </a:ext>
            </a:extLst>
          </p:cNvPr>
          <p:cNvSpPr txBox="1"/>
          <p:nvPr/>
        </p:nvSpPr>
        <p:spPr>
          <a:xfrm>
            <a:off x="8029524" y="6574076"/>
            <a:ext cx="187647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</a:t>
            </a:r>
            <a:r>
              <a:rPr lang="it-IT" sz="1245" dirty="0" smtClean="0"/>
              <a:t>10</a:t>
            </a:r>
            <a:endParaRPr lang="it-IT" sz="1245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2877" y="749609"/>
            <a:ext cx="7998645" cy="4596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69458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CasellaDiTesto 33">
            <a:extLst>
              <a:ext uri="{FF2B5EF4-FFF2-40B4-BE49-F238E27FC236}">
                <a16:creationId xmlns:a16="http://schemas.microsoft.com/office/drawing/2014/main" xmlns="" id="{7FB777EA-B1A5-4752-B3DC-2F48BDC16653}"/>
              </a:ext>
            </a:extLst>
          </p:cNvPr>
          <p:cNvSpPr txBox="1"/>
          <p:nvPr/>
        </p:nvSpPr>
        <p:spPr>
          <a:xfrm>
            <a:off x="8108075" y="6520854"/>
            <a:ext cx="1971960" cy="283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</a:t>
            </a:r>
            <a:r>
              <a:rPr lang="it-IT" sz="1245" dirty="0" smtClean="0"/>
              <a:t>2</a:t>
            </a:r>
            <a:endParaRPr lang="it-IT" sz="1245" dirty="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xmlns="" id="{D4394E70-8581-4BFA-9C4D-57C8D99AF87E}"/>
              </a:ext>
            </a:extLst>
          </p:cNvPr>
          <p:cNvSpPr txBox="1"/>
          <p:nvPr/>
        </p:nvSpPr>
        <p:spPr>
          <a:xfrm>
            <a:off x="460823" y="5969111"/>
            <a:ext cx="92248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Whole electropherogram related to AHR exon 10 sequence data </a:t>
            </a:r>
            <a:r>
              <a:rPr lang="en-US" sz="1200" dirty="0" smtClean="0"/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7:17339632+17340337, c.1239-c.2056) of germline DNA depicted in Figure 1C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righ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ne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Ima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elect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rti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n in the original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lighted in red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9365" y="700488"/>
            <a:ext cx="7078069" cy="49320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356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0B8044FD-D9BC-4594-8412-87378BF42634}"/>
              </a:ext>
            </a:extLst>
          </p:cNvPr>
          <p:cNvSpPr txBox="1"/>
          <p:nvPr/>
        </p:nvSpPr>
        <p:spPr>
          <a:xfrm>
            <a:off x="8108075" y="6573947"/>
            <a:ext cx="179632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3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B9FB032B-C77E-4B9F-A3F4-AB8770A91AAC}"/>
              </a:ext>
            </a:extLst>
          </p:cNvPr>
          <p:cNvSpPr txBox="1"/>
          <p:nvPr/>
        </p:nvSpPr>
        <p:spPr>
          <a:xfrm>
            <a:off x="371146" y="6069578"/>
            <a:ext cx="91552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Who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ectropherogram related to AHR exon 10 sequence data </a:t>
            </a:r>
            <a:r>
              <a:rPr lang="en-US" sz="1200" dirty="0" smtClean="0"/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7:17339632+17340337, c.1239-c.2056) of normal tissue DNA depicted in Figure 1C (lower pane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Ima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elect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rti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n in the original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lighted in red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3483" y="743835"/>
            <a:ext cx="6730567" cy="4980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49424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xmlns="" id="{DC1BB39C-5334-4DB9-B83B-E0BF19820461}"/>
              </a:ext>
            </a:extLst>
          </p:cNvPr>
          <p:cNvSpPr txBox="1"/>
          <p:nvPr/>
        </p:nvSpPr>
        <p:spPr>
          <a:xfrm>
            <a:off x="190797" y="5837935"/>
            <a:ext cx="95514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Representative sequencing analysis of the 5’ region of AHR exon 10 (chr7:17338986+17339118; c.1161-1293), surrounding the deletion region in germlin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tumor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NA of the patient #1. 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ne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ositi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.17339071_17339079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s indicated. Panel B shows the alter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quenc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the corresponding tumor DNA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xmlns="" id="{0B8044FD-D9BC-4594-8412-87378BF42634}"/>
              </a:ext>
            </a:extLst>
          </p:cNvPr>
          <p:cNvSpPr txBox="1"/>
          <p:nvPr/>
        </p:nvSpPr>
        <p:spPr>
          <a:xfrm>
            <a:off x="8108075" y="6573947"/>
            <a:ext cx="179632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4</a:t>
            </a: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658" y="332003"/>
            <a:ext cx="8809484" cy="52795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84052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F393760C-12DB-4CFC-B442-5B7A184447BC}"/>
              </a:ext>
            </a:extLst>
          </p:cNvPr>
          <p:cNvSpPr txBox="1"/>
          <p:nvPr/>
        </p:nvSpPr>
        <p:spPr>
          <a:xfrm>
            <a:off x="289833" y="6023344"/>
            <a:ext cx="97081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Whol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lectropherogram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lated to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HR exon 10 sequenc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ta (c.1026-c.1243 in panel A and c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26-c.1576 in panel B) of normal tissue cDNA depicted in Figure 2B.  Imag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elected portions shown in the original Figure are highlighted in red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xmlns="" id="{0B8044FD-D9BC-4594-8412-87378BF42634}"/>
              </a:ext>
            </a:extLst>
          </p:cNvPr>
          <p:cNvSpPr txBox="1"/>
          <p:nvPr/>
        </p:nvSpPr>
        <p:spPr>
          <a:xfrm>
            <a:off x="8108075" y="6573947"/>
            <a:ext cx="179632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</a:t>
            </a:r>
            <a:r>
              <a:rPr lang="it-IT" sz="1245" dirty="0" smtClean="0"/>
              <a:t>5</a:t>
            </a:r>
            <a:endParaRPr lang="it-IT" sz="1245"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556" y="731648"/>
            <a:ext cx="9681287" cy="48528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30386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xmlns="" id="{337C1038-F961-445C-9C1C-19B1CC8BAD5C}"/>
              </a:ext>
            </a:extLst>
          </p:cNvPr>
          <p:cNvSpPr txBox="1"/>
          <p:nvPr/>
        </p:nvSpPr>
        <p:spPr>
          <a:xfrm>
            <a:off x="277021" y="6112282"/>
            <a:ext cx="96289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Who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ectropherograms related to AHR exon 10 sequence data (c.1026-c.1243 in panel A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.1026-c.1579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panel B) of normal tissue cDNA depicted in Figure 2C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mag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elected portions shown in the original Figure are highlighted in red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0B8044FD-D9BC-4594-8412-87378BF42634}"/>
              </a:ext>
            </a:extLst>
          </p:cNvPr>
          <p:cNvSpPr txBox="1"/>
          <p:nvPr/>
        </p:nvSpPr>
        <p:spPr>
          <a:xfrm>
            <a:off x="8108075" y="6573947"/>
            <a:ext cx="179632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</a:t>
            </a:r>
            <a:r>
              <a:rPr lang="it-IT" sz="1245" dirty="0" smtClean="0"/>
              <a:t>6</a:t>
            </a:r>
            <a:endParaRPr lang="it-IT" sz="1245" dirty="0"/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939" y="284567"/>
            <a:ext cx="6127011" cy="5797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6904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CasellaDiTesto 33">
            <a:extLst>
              <a:ext uri="{FF2B5EF4-FFF2-40B4-BE49-F238E27FC236}">
                <a16:creationId xmlns:a16="http://schemas.microsoft.com/office/drawing/2014/main" xmlns="" id="{7FB777EA-B1A5-4752-B3DC-2F48BDC16653}"/>
              </a:ext>
            </a:extLst>
          </p:cNvPr>
          <p:cNvSpPr txBox="1"/>
          <p:nvPr/>
        </p:nvSpPr>
        <p:spPr>
          <a:xfrm>
            <a:off x="8108075" y="6573947"/>
            <a:ext cx="179632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</a:t>
            </a:r>
            <a:r>
              <a:rPr lang="it-IT" sz="1245" dirty="0" smtClean="0"/>
              <a:t>7</a:t>
            </a:r>
            <a:endParaRPr lang="it-IT" sz="1245" dirty="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xmlns="" id="{D4394E70-8581-4BFA-9C4D-57C8D99AF87E}"/>
              </a:ext>
            </a:extLst>
          </p:cNvPr>
          <p:cNvSpPr txBox="1"/>
          <p:nvPr/>
        </p:nvSpPr>
        <p:spPr>
          <a:xfrm>
            <a:off x="250082" y="5720858"/>
            <a:ext cx="93533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Who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ectropherogram related to AHR exon 10 sequence data </a:t>
            </a:r>
            <a:r>
              <a:rPr lang="en-US" sz="1200" dirty="0"/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7:17339632+17340337, c.1239-c.2056) of germline DNA depicted in Figure 3A (left panel)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quenc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as perform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th forwar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imer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age of selected portion shown in the original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lighted in re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9503" y="106479"/>
            <a:ext cx="8114479" cy="54076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93014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Immagine 67">
            <a:extLst>
              <a:ext uri="{FF2B5EF4-FFF2-40B4-BE49-F238E27FC236}">
                <a16:creationId xmlns:a16="http://schemas.microsoft.com/office/drawing/2014/main" xmlns="" id="{B9CCFF5D-2BCE-49D6-9C5F-9D020224E7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931" t="18615" r="48856" b="78203"/>
          <a:stretch/>
        </p:blipFill>
        <p:spPr>
          <a:xfrm>
            <a:off x="1093396" y="6107282"/>
            <a:ext cx="41511" cy="58293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3AF74471-5962-4C09-A0B2-7FEF17293102}"/>
              </a:ext>
            </a:extLst>
          </p:cNvPr>
          <p:cNvSpPr txBox="1"/>
          <p:nvPr/>
        </p:nvSpPr>
        <p:spPr>
          <a:xfrm>
            <a:off x="336013" y="5767600"/>
            <a:ext cx="92651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Who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ectropherogram related to AHR exon 10 sequence data </a:t>
            </a:r>
            <a:r>
              <a:rPr lang="en-US" sz="1200" dirty="0"/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7:17339632+17340337, c.1239-c.2056) of germline DNA depicted in Figure 3A (right panel). Sequence analysis was performed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verse primer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age of selected portion shown in the original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lighted in red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xmlns="" id="{0B8044FD-D9BC-4594-8412-87378BF42634}"/>
              </a:ext>
            </a:extLst>
          </p:cNvPr>
          <p:cNvSpPr txBox="1"/>
          <p:nvPr/>
        </p:nvSpPr>
        <p:spPr>
          <a:xfrm>
            <a:off x="8108075" y="6573947"/>
            <a:ext cx="179632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</a:t>
            </a:r>
            <a:r>
              <a:rPr lang="it-IT" sz="1245" dirty="0" smtClean="0"/>
              <a:t>8</a:t>
            </a:r>
            <a:endParaRPr lang="it-IT" sz="1245" dirty="0"/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0426" y="444795"/>
            <a:ext cx="7096359" cy="49016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18431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CasellaDiTesto 18">
            <a:extLst>
              <a:ext uri="{FF2B5EF4-FFF2-40B4-BE49-F238E27FC236}">
                <a16:creationId xmlns:a16="http://schemas.microsoft.com/office/drawing/2014/main" xmlns="" id="{36D11EBB-6385-47C5-979B-BEC692EA9825}"/>
              </a:ext>
            </a:extLst>
          </p:cNvPr>
          <p:cNvSpPr txBox="1"/>
          <p:nvPr/>
        </p:nvSpPr>
        <p:spPr>
          <a:xfrm>
            <a:off x="154235" y="5600623"/>
            <a:ext cx="94855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Who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ectropherogram related to AHR exon 10 sequence dat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hr7:17339322+17339650; c. 1497-c. 1825)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umor DNA #1 depicted in Figure 3B (left panel). Sequence analysis was perform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ith forwar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imer.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ma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selected portion shown in the original 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lighted in red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xmlns="" id="{0B8044FD-D9BC-4594-8412-87378BF42634}"/>
              </a:ext>
            </a:extLst>
          </p:cNvPr>
          <p:cNvSpPr txBox="1"/>
          <p:nvPr/>
        </p:nvSpPr>
        <p:spPr>
          <a:xfrm>
            <a:off x="8108075" y="6573947"/>
            <a:ext cx="1796326" cy="28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45" dirty="0"/>
              <a:t>Re A et </a:t>
            </a:r>
            <a:r>
              <a:rPr lang="it-IT" sz="1245" dirty="0" err="1"/>
              <a:t>al_Suppl</a:t>
            </a:r>
            <a:r>
              <a:rPr lang="it-IT" sz="1245" dirty="0"/>
              <a:t> Figure </a:t>
            </a:r>
            <a:r>
              <a:rPr lang="it-IT" sz="1245" dirty="0" smtClean="0"/>
              <a:t>9</a:t>
            </a:r>
            <a:endParaRPr lang="it-IT" sz="1245" dirty="0"/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219" y="536628"/>
            <a:ext cx="7803556" cy="4737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5077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11</TotalTime>
  <Words>557</Words>
  <Application>Microsoft Office PowerPoint</Application>
  <PresentationFormat>A4 (21x29,7 cm)</PresentationFormat>
  <Paragraphs>24</Paragraphs>
  <Slides>10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gnese</dc:creator>
  <cp:lastModifiedBy>Dott.ssa Agnese Re</cp:lastModifiedBy>
  <cp:revision>344</cp:revision>
  <cp:lastPrinted>2020-09-21T12:05:02Z</cp:lastPrinted>
  <dcterms:created xsi:type="dcterms:W3CDTF">2020-03-24T11:44:15Z</dcterms:created>
  <dcterms:modified xsi:type="dcterms:W3CDTF">2020-09-25T14:36:41Z</dcterms:modified>
</cp:coreProperties>
</file>